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71600" y="1142640"/>
            <a:ext cx="23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164D7C-D638-405A-A2A0-35A3281FD4D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5BA714-884B-4565-8B79-9E798BB0767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16037A-61AA-454F-BEE6-A642D34D22C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5FE605-C684-4D38-8187-E5769E0E8C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3769C-2757-49EC-ABB5-593E86D850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E1F0F-2395-481A-8114-2698B576C1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19A6A-2BF9-4515-8C50-E5DE7E7828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6D04A-0CC7-47B1-BDFF-E24AF85DAB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1CAE4-AA00-4D4A-8604-087AA9524A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2578D-7CF8-475C-89DC-E9750DBDF2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33B7F-9CEE-449A-8F62-79E8CA1779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EB879-6347-4A56-8B2A-7A653ACE31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215E6-79A6-412B-8B8F-A0EE31F112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7CC45-F155-454D-A3DE-ED63790179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88775-04B7-480D-94E6-F316B2CE54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4091A9-4D86-4F50-A823-2895CEE2B96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本框 1"/>
          <p:cNvSpPr/>
          <p:nvPr/>
        </p:nvSpPr>
        <p:spPr>
          <a:xfrm>
            <a:off x="907920" y="1619280"/>
            <a:ext cx="5113440" cy="390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TCTTTAATATATAATTTTTATTTCTGGTTATAGAAACAAATGCTAAGAGGAGAAAACAGAGCTTCCCCACCCACATACAACAACCGAATAGATAAAAGAACAGTTCAAATGAATGAAAAAGAAAGTAGAAATTTCCACTTTGTTATAGCTTTAAAACATTAACGTCTAATAATAGTTAGAAATCACATTCAGGTGTCAAAACTTTTTGTTTAAAAAAAGGATGGTTCTGTTATAAAAAAATACTGTATCCCGTTTGAAATGAACGCCCAGGTGTTGCTGCTTGGTGTGTGGGTCCGCAGGCCTTTCTTACCCCTGCCTCCAGAGTGGGACCTTCGCTCACTGAGGTGGGGCACGTCCCATCTCTGGAACTCGGATTCCCATCGTATTGGGTACCACTGCTTTTAAAGCACTAAGTGTTAAACATATCATGAAAATACTTGACAGCCACTGTAAAAAATGAAACAAAACAAAATCACACATGCTCTCACGCACGCACACACACA</a:t>
            </a: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GACTTAGGGGAAGAGGTCCTGGGGGCCCTAGGCAGCCTGTGTTTGACAGCTTAGCCCAAGTACAGAAACACATGCTTTTCATTGTGACTGAAGCACTCTAAGTATTTTGAGAGAGAGAGACACACACACACACACAGAGACAGACAGACAGACAGACTCCTCACTGAGGGATCTTTACCACTGCTGGCTCGGCACCAGCTGTGAGGGCAGCCCTCAGCCTCCAGTCCCACCGGCTTACCTCCCCTTAGCTCTTACCAAACTGCTCTCCCTCTAGCTGGCCGCTTCCTCCCTTCGAGCATCCTCTGTCCTGCCTCGTGCCCAGATGGTACCTCTGGAGAAGGCATGCGGCTGGCCTCATCTGTGGGACAGGCCTGCCCAGGCTGTTATGCCCCGTGCCCATGGGGGGGAGTGTGTGTGTGGGGGGCAGGTTCTAGAATGTTCCCTGCAGTAGAGCTGAGGCCTGATAGAGGGAACCTTGGAGCAGTGAGGCAATGCAGAGGAGCAGCCAGGACCACTCAGGGGGCTTTTGTTCTTCACCACGAGTAGAAAACCTACTTTTCCTAAGGAAACATCTGTGGTTGGTTCAAAAATGTTCCCTTGCCAAGCAGCTGTGACGTTAGGGGTTAGGGAGGGCAGAGAGAGAGAGAGACGTGCCATATGCCAGTCTGTGGGGGCACCTAGGCCACACCCTGCTGTGTCACCAGTGTAGCAGCTTTTGGTACAGAAACAAACAAACAAAAAAAGACAAAACGCAAACAGCGCTGGGCCATGGTAGCATGTAGGCCATCACCCCAGAAATTCAGGAAGCTGAGGCAAGAGGACTGGGAGTTCAAGGCCAGCCTGGGCAGCTTGT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"/>
          <p:cNvSpPr/>
          <p:nvPr/>
        </p:nvSpPr>
        <p:spPr>
          <a:xfrm>
            <a:off x="404640" y="460440"/>
            <a:ext cx="165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本框 1"/>
          <p:cNvSpPr/>
          <p:nvPr/>
        </p:nvSpPr>
        <p:spPr>
          <a:xfrm>
            <a:off x="907920" y="5796000"/>
            <a:ext cx="511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 The sequence of Foxk1-AS.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boundary of exon and intron is marked in red.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 Box 2"/>
          <p:cNvSpPr/>
          <p:nvPr/>
        </p:nvSpPr>
        <p:spPr>
          <a:xfrm>
            <a:off x="404640" y="179280"/>
            <a:ext cx="165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对象 1"/>
          <p:cNvGraphicFramePr/>
          <p:nvPr/>
        </p:nvGraphicFramePr>
        <p:xfrm>
          <a:off x="1728720" y="3797280"/>
          <a:ext cx="1709640" cy="2719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3" name="对象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28720" y="3797280"/>
                    <a:ext cx="1709640" cy="2719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对象 2"/>
          <p:cNvGraphicFramePr/>
          <p:nvPr/>
        </p:nvGraphicFramePr>
        <p:xfrm>
          <a:off x="3438360" y="4000680"/>
          <a:ext cx="1579680" cy="2409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5" name="对象 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38360" y="4000680"/>
                    <a:ext cx="1579680" cy="2409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Object 2"/>
          <p:cNvGraphicFramePr/>
          <p:nvPr/>
        </p:nvGraphicFramePr>
        <p:xfrm>
          <a:off x="1038240" y="966960"/>
          <a:ext cx="2376360" cy="2484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7" name="Object 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038240" y="966960"/>
                    <a:ext cx="2376360" cy="248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8" name="文本框 1"/>
          <p:cNvSpPr/>
          <p:nvPr/>
        </p:nvSpPr>
        <p:spPr>
          <a:xfrm>
            <a:off x="838080" y="835200"/>
            <a:ext cx="4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9"/>
          <p:cNvSpPr/>
          <p:nvPr/>
        </p:nvSpPr>
        <p:spPr>
          <a:xfrm>
            <a:off x="3443400" y="900000"/>
            <a:ext cx="41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本框 1"/>
          <p:cNvSpPr/>
          <p:nvPr/>
        </p:nvSpPr>
        <p:spPr>
          <a:xfrm>
            <a:off x="1355760" y="3884760"/>
            <a:ext cx="4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1" name="Object 2"/>
          <p:cNvGraphicFramePr/>
          <p:nvPr/>
        </p:nvGraphicFramePr>
        <p:xfrm>
          <a:off x="3639960" y="965160"/>
          <a:ext cx="2428920" cy="24559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2" name="Object 2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639960" y="965160"/>
                    <a:ext cx="2428920" cy="245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3" name="TextBox 20"/>
          <p:cNvSpPr/>
          <p:nvPr/>
        </p:nvSpPr>
        <p:spPr>
          <a:xfrm>
            <a:off x="765000" y="6792840"/>
            <a:ext cx="55404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igure S2.  Knockdown of Foxk1-AS in C2C12 cells and tibialis anterior have no effect on gene expression of Foxk1. (A) Two of three knockdown lentivirus successfully decreased Foxk1-AS levels by 40% in C2C12 cells . (B) Knockdown of Foxk1-AS in C2C12 cells have no effect on gene expression of Foxk1. (C) Knockdown of Foxk1-AS in tibialis anterior have no effect on gene expression of Foxk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0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7-26T01:13:50Z</dcterms:created>
  <dc:creator>stemcell</dc:creator>
  <dc:description/>
  <dc:language>en-US</dc:language>
  <cp:lastModifiedBy>罗玉萍</cp:lastModifiedBy>
  <dcterms:modified xsi:type="dcterms:W3CDTF">2022-03-23T03:28:16Z</dcterms:modified>
  <cp:revision>421</cp:revision>
  <dc:subject/>
  <dc:title>幻灯片 1</dc:title>
</cp:coreProperties>
</file>